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5"/>
  </p:notesMasterIdLst>
  <p:sldIdLst>
    <p:sldId id="257" r:id="rId2"/>
    <p:sldId id="260" r:id="rId3"/>
    <p:sldId id="259" r:id="rId4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79" d="100"/>
          <a:sy n="79" d="100"/>
        </p:scale>
        <p:origin x="216" y="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30881C1-C4D6-4F14-BD6C-F72BE910E7A0}" type="datetimeFigureOut">
              <a:rPr lang="en-GB" smtClean="0"/>
              <a:t>01/03/2017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5B8214D-5F3F-44D6-BC03-E46EFD38A8C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355558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5B8214D-5F3F-44D6-BC03-E46EFD38A8CD}" type="slidenum">
              <a:rPr lang="en-GB" smtClean="0"/>
              <a:t>3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3524673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4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189" indent="0" algn="ctr">
              <a:buNone/>
              <a:defRPr sz="2000"/>
            </a:lvl2pPr>
            <a:lvl3pPr marL="914378" indent="0" algn="ctr">
              <a:buNone/>
              <a:defRPr sz="1800"/>
            </a:lvl3pPr>
            <a:lvl4pPr marL="1371566" indent="0" algn="ctr">
              <a:buNone/>
              <a:defRPr sz="1600"/>
            </a:lvl4pPr>
            <a:lvl5pPr marL="1828754" indent="0" algn="ctr">
              <a:buNone/>
              <a:defRPr sz="1600"/>
            </a:lvl5pPr>
            <a:lvl6pPr marL="2285943" indent="0" algn="ctr">
              <a:buNone/>
              <a:defRPr sz="1600"/>
            </a:lvl6pPr>
            <a:lvl7pPr marL="2743132" indent="0" algn="ctr">
              <a:buNone/>
              <a:defRPr sz="1600"/>
            </a:lvl7pPr>
            <a:lvl8pPr marL="3200320" indent="0" algn="ctr">
              <a:buNone/>
              <a:defRPr sz="1600"/>
            </a:lvl8pPr>
            <a:lvl9pPr marL="3657509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61F4B2-8383-4CEE-B040-87016A65A27A}" type="datetimeFigureOut">
              <a:rPr lang="en-GB" smtClean="0"/>
              <a:t>01/03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68E61A-1FCA-4CA4-A026-A7BFE199D23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588597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61F4B2-8383-4CEE-B040-87016A65A27A}" type="datetimeFigureOut">
              <a:rPr lang="en-GB" smtClean="0"/>
              <a:t>01/03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68E61A-1FCA-4CA4-A026-A7BFE199D23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562888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6" y="365126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1" y="365126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61F4B2-8383-4CEE-B040-87016A65A27A}" type="datetimeFigureOut">
              <a:rPr lang="en-GB" smtClean="0"/>
              <a:t>01/03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68E61A-1FCA-4CA4-A026-A7BFE199D23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503283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61F4B2-8383-4CEE-B040-87016A65A27A}" type="datetimeFigureOut">
              <a:rPr lang="en-GB" smtClean="0"/>
              <a:t>01/03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68E61A-1FCA-4CA4-A026-A7BFE199D23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849353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9" y="1709740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9" y="4589465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189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378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56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75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594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132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32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509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61F4B2-8383-4CEE-B040-87016A65A27A}" type="datetimeFigureOut">
              <a:rPr lang="en-GB" smtClean="0"/>
              <a:t>01/03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68E61A-1FCA-4CA4-A026-A7BFE199D23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632683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1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1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61F4B2-8383-4CEE-B040-87016A65A27A}" type="datetimeFigureOut">
              <a:rPr lang="en-GB" smtClean="0"/>
              <a:t>01/03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68E61A-1FCA-4CA4-A026-A7BFE199D23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512367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2" y="365127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4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9" indent="0">
              <a:buNone/>
              <a:defRPr sz="2000" b="1"/>
            </a:lvl2pPr>
            <a:lvl3pPr marL="914378" indent="0">
              <a:buNone/>
              <a:defRPr sz="1800" b="1"/>
            </a:lvl3pPr>
            <a:lvl4pPr marL="1371566" indent="0">
              <a:buNone/>
              <a:defRPr sz="1600" b="1"/>
            </a:lvl4pPr>
            <a:lvl5pPr marL="1828754" indent="0">
              <a:buNone/>
              <a:defRPr sz="1600" b="1"/>
            </a:lvl5pPr>
            <a:lvl6pPr marL="2285943" indent="0">
              <a:buNone/>
              <a:defRPr sz="1600" b="1"/>
            </a:lvl6pPr>
            <a:lvl7pPr marL="2743132" indent="0">
              <a:buNone/>
              <a:defRPr sz="1600" b="1"/>
            </a:lvl7pPr>
            <a:lvl8pPr marL="3200320" indent="0">
              <a:buNone/>
              <a:defRPr sz="1600" b="1"/>
            </a:lvl8pPr>
            <a:lvl9pPr marL="3657509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1" y="1681164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9" indent="0">
              <a:buNone/>
              <a:defRPr sz="2000" b="1"/>
            </a:lvl2pPr>
            <a:lvl3pPr marL="914378" indent="0">
              <a:buNone/>
              <a:defRPr sz="1800" b="1"/>
            </a:lvl3pPr>
            <a:lvl4pPr marL="1371566" indent="0">
              <a:buNone/>
              <a:defRPr sz="1600" b="1"/>
            </a:lvl4pPr>
            <a:lvl5pPr marL="1828754" indent="0">
              <a:buNone/>
              <a:defRPr sz="1600" b="1"/>
            </a:lvl5pPr>
            <a:lvl6pPr marL="2285943" indent="0">
              <a:buNone/>
              <a:defRPr sz="1600" b="1"/>
            </a:lvl6pPr>
            <a:lvl7pPr marL="2743132" indent="0">
              <a:buNone/>
              <a:defRPr sz="1600" b="1"/>
            </a:lvl7pPr>
            <a:lvl8pPr marL="3200320" indent="0">
              <a:buNone/>
              <a:defRPr sz="1600" b="1"/>
            </a:lvl8pPr>
            <a:lvl9pPr marL="3657509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1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61F4B2-8383-4CEE-B040-87016A65A27A}" type="datetimeFigureOut">
              <a:rPr lang="en-GB" smtClean="0"/>
              <a:t>01/03/2017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68E61A-1FCA-4CA4-A026-A7BFE199D23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419335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61F4B2-8383-4CEE-B040-87016A65A27A}" type="datetimeFigureOut">
              <a:rPr lang="en-GB" smtClean="0"/>
              <a:t>01/03/2017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68E61A-1FCA-4CA4-A026-A7BFE199D23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982691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61F4B2-8383-4CEE-B040-87016A65A27A}" type="datetimeFigureOut">
              <a:rPr lang="en-GB" smtClean="0"/>
              <a:t>01/03/2017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68E61A-1FCA-4CA4-A026-A7BFE199D23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631394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9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7"/>
            <a:ext cx="4629151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9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89" indent="0">
              <a:buNone/>
              <a:defRPr sz="1400"/>
            </a:lvl2pPr>
            <a:lvl3pPr marL="914378" indent="0">
              <a:buNone/>
              <a:defRPr sz="1200"/>
            </a:lvl3pPr>
            <a:lvl4pPr marL="1371566" indent="0">
              <a:buNone/>
              <a:defRPr sz="1000"/>
            </a:lvl4pPr>
            <a:lvl5pPr marL="1828754" indent="0">
              <a:buNone/>
              <a:defRPr sz="1000"/>
            </a:lvl5pPr>
            <a:lvl6pPr marL="2285943" indent="0">
              <a:buNone/>
              <a:defRPr sz="1000"/>
            </a:lvl6pPr>
            <a:lvl7pPr marL="2743132" indent="0">
              <a:buNone/>
              <a:defRPr sz="1000"/>
            </a:lvl7pPr>
            <a:lvl8pPr marL="3200320" indent="0">
              <a:buNone/>
              <a:defRPr sz="1000"/>
            </a:lvl8pPr>
            <a:lvl9pPr marL="3657509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61F4B2-8383-4CEE-B040-87016A65A27A}" type="datetimeFigureOut">
              <a:rPr lang="en-GB" smtClean="0"/>
              <a:t>01/03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68E61A-1FCA-4CA4-A026-A7BFE199D23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634838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9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7"/>
            <a:ext cx="4629151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189" indent="0">
              <a:buNone/>
              <a:defRPr sz="2800"/>
            </a:lvl2pPr>
            <a:lvl3pPr marL="914378" indent="0">
              <a:buNone/>
              <a:defRPr sz="2400"/>
            </a:lvl3pPr>
            <a:lvl4pPr marL="1371566" indent="0">
              <a:buNone/>
              <a:defRPr sz="2000"/>
            </a:lvl4pPr>
            <a:lvl5pPr marL="1828754" indent="0">
              <a:buNone/>
              <a:defRPr sz="2000"/>
            </a:lvl5pPr>
            <a:lvl6pPr marL="2285943" indent="0">
              <a:buNone/>
              <a:defRPr sz="2000"/>
            </a:lvl6pPr>
            <a:lvl7pPr marL="2743132" indent="0">
              <a:buNone/>
              <a:defRPr sz="2000"/>
            </a:lvl7pPr>
            <a:lvl8pPr marL="3200320" indent="0">
              <a:buNone/>
              <a:defRPr sz="2000"/>
            </a:lvl8pPr>
            <a:lvl9pPr marL="3657509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9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89" indent="0">
              <a:buNone/>
              <a:defRPr sz="1400"/>
            </a:lvl2pPr>
            <a:lvl3pPr marL="914378" indent="0">
              <a:buNone/>
              <a:defRPr sz="1200"/>
            </a:lvl3pPr>
            <a:lvl4pPr marL="1371566" indent="0">
              <a:buNone/>
              <a:defRPr sz="1000"/>
            </a:lvl4pPr>
            <a:lvl5pPr marL="1828754" indent="0">
              <a:buNone/>
              <a:defRPr sz="1000"/>
            </a:lvl5pPr>
            <a:lvl6pPr marL="2285943" indent="0">
              <a:buNone/>
              <a:defRPr sz="1000"/>
            </a:lvl6pPr>
            <a:lvl7pPr marL="2743132" indent="0">
              <a:buNone/>
              <a:defRPr sz="1000"/>
            </a:lvl7pPr>
            <a:lvl8pPr marL="3200320" indent="0">
              <a:buNone/>
              <a:defRPr sz="1000"/>
            </a:lvl8pPr>
            <a:lvl9pPr marL="3657509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61F4B2-8383-4CEE-B040-87016A65A27A}" type="datetimeFigureOut">
              <a:rPr lang="en-GB" smtClean="0"/>
              <a:t>01/03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68E61A-1FCA-4CA4-A026-A7BFE199D23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079459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1" y="365127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1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1" y="6356352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61F4B2-8383-4CEE-B040-87016A65A27A}" type="datetimeFigureOut">
              <a:rPr lang="en-GB" smtClean="0"/>
              <a:t>01/03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1" y="6356352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1" y="6356352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68E61A-1FCA-4CA4-A026-A7BFE199D23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444820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378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594" indent="-228594" algn="l" defTabSz="914378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783" indent="-228594" algn="l" defTabSz="914378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972" indent="-228594" algn="l" defTabSz="914378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160" indent="-228594" algn="l" defTabSz="914378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348" indent="-228594" algn="l" defTabSz="914378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537" indent="-228594" algn="l" defTabSz="914378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726" indent="-228594" algn="l" defTabSz="914378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915" indent="-228594" algn="l" defTabSz="914378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103" indent="-228594" algn="l" defTabSz="914378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89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378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566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754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943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132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320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509" algn="l" defTabSz="91437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3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3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39077" y="5112369"/>
            <a:ext cx="7886700" cy="1500187"/>
          </a:xfrm>
        </p:spPr>
        <p:txBody>
          <a:bodyPr>
            <a:normAutofit/>
          </a:bodyPr>
          <a:lstStyle/>
          <a:p>
            <a:r>
              <a:rPr lang="et-EE" sz="1200" dirty="0"/>
              <a:t>Figure </a:t>
            </a:r>
            <a:r>
              <a:rPr lang="en-GB" sz="1200" dirty="0"/>
              <a:t>1</a:t>
            </a:r>
            <a:r>
              <a:rPr lang="et-EE" sz="1200" dirty="0"/>
              <a:t>. a) Mean strategy score (</a:t>
            </a:r>
            <a:r>
              <a:rPr lang="en-GB" sz="1200" dirty="0"/>
              <a:t>the number of distinct boxes used to start a new search; lower is better) (±SEM)</a:t>
            </a:r>
            <a:r>
              <a:rPr lang="et-EE" sz="1200" dirty="0"/>
              <a:t> in the Spatial Working Memory (SWM) test across </a:t>
            </a:r>
            <a:r>
              <a:rPr lang="et-EE" sz="1200" i="1" dirty="0"/>
              <a:t>DRD2</a:t>
            </a:r>
            <a:r>
              <a:rPr lang="et-EE" sz="1200" dirty="0"/>
              <a:t> genotypes</a:t>
            </a:r>
            <a:r>
              <a:rPr lang="en-GB" sz="1200" dirty="0"/>
              <a:t>.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60203" y="640135"/>
            <a:ext cx="5244447" cy="436721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7296966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9" y="5227139"/>
            <a:ext cx="7886700" cy="1500187"/>
          </a:xfrm>
        </p:spPr>
        <p:txBody>
          <a:bodyPr/>
          <a:lstStyle/>
          <a:p>
            <a:pPr lvl="0"/>
            <a:r>
              <a:rPr lang="en-GB" sz="1200" dirty="0">
                <a:solidFill>
                  <a:prstClr val="black"/>
                </a:solidFill>
              </a:rPr>
              <a:t>Figure 2. </a:t>
            </a:r>
            <a:r>
              <a:rPr lang="et-EE" sz="1200" dirty="0">
                <a:solidFill>
                  <a:prstClr val="black"/>
                </a:solidFill>
              </a:rPr>
              <a:t>Mean number of choices to correct answer </a:t>
            </a:r>
            <a:r>
              <a:rPr lang="en-GB" sz="1200" dirty="0">
                <a:solidFill>
                  <a:prstClr val="black"/>
                </a:solidFill>
              </a:rPr>
              <a:t>(±SEM) </a:t>
            </a:r>
            <a:r>
              <a:rPr lang="et-EE" sz="1200" dirty="0">
                <a:solidFill>
                  <a:prstClr val="black"/>
                </a:solidFill>
              </a:rPr>
              <a:t>in One Touch Stockings of Cambridge </a:t>
            </a:r>
            <a:r>
              <a:rPr lang="en-GB" sz="1200" dirty="0">
                <a:solidFill>
                  <a:prstClr val="black"/>
                </a:solidFill>
              </a:rPr>
              <a:t>(OTS) </a:t>
            </a:r>
            <a:r>
              <a:rPr lang="et-EE" sz="1200" dirty="0">
                <a:solidFill>
                  <a:prstClr val="black"/>
                </a:solidFill>
              </a:rPr>
              <a:t>test across </a:t>
            </a:r>
            <a:r>
              <a:rPr lang="et-EE" sz="1200" i="1" dirty="0">
                <a:solidFill>
                  <a:prstClr val="black"/>
                </a:solidFill>
              </a:rPr>
              <a:t>DRD2</a:t>
            </a:r>
            <a:r>
              <a:rPr lang="et-EE" sz="1200" dirty="0">
                <a:solidFill>
                  <a:prstClr val="black"/>
                </a:solidFill>
              </a:rPr>
              <a:t> genotypes.</a:t>
            </a:r>
            <a:r>
              <a:rPr lang="en-GB" sz="1200" dirty="0">
                <a:solidFill>
                  <a:prstClr val="black"/>
                </a:solidFill>
              </a:rPr>
              <a:t> *p≤.05</a:t>
            </a:r>
          </a:p>
          <a:p>
            <a:endParaRPr lang="en-GB" dirty="0"/>
          </a:p>
        </p:txBody>
      </p:sp>
      <p:pic>
        <p:nvPicPr>
          <p:cNvPr id="9" name="Picture 8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76030" y="585418"/>
            <a:ext cx="5382417" cy="436445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3859433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t-EE" sz="1200" dirty="0"/>
              <a:t>Figure </a:t>
            </a:r>
            <a:r>
              <a:rPr lang="en-GB" sz="1200" dirty="0"/>
              <a:t>3</a:t>
            </a:r>
            <a:r>
              <a:rPr lang="et-EE" sz="1200" dirty="0"/>
              <a:t>. a) Mean probability of hit in the Rapid Visual Processing (RVP) t</a:t>
            </a:r>
            <a:r>
              <a:rPr lang="en-GB" sz="1200" dirty="0" err="1"/>
              <a:t>est</a:t>
            </a:r>
            <a:r>
              <a:rPr lang="et-EE" sz="1200" dirty="0"/>
              <a:t>. b) Mean number of false alarms in the RVP </a:t>
            </a:r>
            <a:r>
              <a:rPr lang="en-GB" sz="1200" dirty="0"/>
              <a:t>test</a:t>
            </a:r>
            <a:r>
              <a:rPr lang="et-EE" sz="1200" dirty="0"/>
              <a:t>. All results are displayed across </a:t>
            </a:r>
            <a:r>
              <a:rPr lang="et-EE" sz="1200" i="1" dirty="0"/>
              <a:t>DRD2</a:t>
            </a:r>
            <a:r>
              <a:rPr lang="et-EE" sz="1200" dirty="0"/>
              <a:t> genotypes, for both Trauma and No Trauma group separately. Trauma categories are based on Childhood Traumatic Events Scale (CTES; Pennebaker &amp; Susman, 1988), where Trauma= a rating of 6-7 on trauma scale and No Trauma= a rating </a:t>
            </a:r>
            <a:r>
              <a:rPr lang="en-GB" sz="1200" dirty="0"/>
              <a:t>&lt;6</a:t>
            </a:r>
            <a:r>
              <a:rPr lang="et-EE" sz="1200" dirty="0"/>
              <a:t>. </a:t>
            </a:r>
            <a:r>
              <a:rPr lang="en-GB" sz="1200" dirty="0"/>
              <a:t>Significant genotype-trauma group interactions were seen for both probability of hit (</a:t>
            </a:r>
            <a:r>
              <a:rPr lang="et-EE" sz="1200" i="1" dirty="0"/>
              <a:t>F</a:t>
            </a:r>
            <a:r>
              <a:rPr lang="et-EE" sz="1200" baseline="-25000" dirty="0"/>
              <a:t>2, 113</a:t>
            </a:r>
            <a:r>
              <a:rPr lang="et-EE" sz="1200" dirty="0"/>
              <a:t>=4.140, </a:t>
            </a:r>
            <a:r>
              <a:rPr lang="et-EE" sz="1200" i="1" dirty="0"/>
              <a:t>p</a:t>
            </a:r>
            <a:r>
              <a:rPr lang="et-EE" sz="1200" dirty="0"/>
              <a:t>=.018, partial </a:t>
            </a:r>
            <a:r>
              <a:rPr lang="et-EE" sz="1200" i="1" dirty="0">
                <a:sym typeface="Symbol" panose="05050102010706020507" pitchFamily="18" charset="2"/>
              </a:rPr>
              <a:t></a:t>
            </a:r>
            <a:r>
              <a:rPr lang="et-EE" sz="1200" i="1" baseline="30000" dirty="0"/>
              <a:t>2</a:t>
            </a:r>
            <a:r>
              <a:rPr lang="et-EE" sz="1200" dirty="0"/>
              <a:t>=.068</a:t>
            </a:r>
            <a:r>
              <a:rPr lang="en-GB" sz="1200" dirty="0"/>
              <a:t>) and mean number of false alarms (</a:t>
            </a:r>
            <a:r>
              <a:rPr lang="et-EE" sz="1200" i="1" dirty="0"/>
              <a:t>F</a:t>
            </a:r>
            <a:r>
              <a:rPr lang="et-EE" sz="1200" baseline="-25000" dirty="0"/>
              <a:t>2, 113</a:t>
            </a:r>
            <a:r>
              <a:rPr lang="et-EE" sz="1200" dirty="0"/>
              <a:t>=5.337, </a:t>
            </a:r>
            <a:r>
              <a:rPr lang="et-EE" sz="1200" i="1" dirty="0"/>
              <a:t>p</a:t>
            </a:r>
            <a:r>
              <a:rPr lang="et-EE" sz="1200" dirty="0"/>
              <a:t>=.006, partial </a:t>
            </a:r>
            <a:r>
              <a:rPr lang="et-EE" sz="1200" i="1" dirty="0">
                <a:sym typeface="Symbol" panose="05050102010706020507" pitchFamily="18" charset="2"/>
              </a:rPr>
              <a:t></a:t>
            </a:r>
            <a:r>
              <a:rPr lang="et-EE" sz="1200" i="1" baseline="30000" dirty="0"/>
              <a:t>2</a:t>
            </a:r>
            <a:r>
              <a:rPr lang="et-EE" sz="1200" dirty="0"/>
              <a:t>=.086</a:t>
            </a:r>
            <a:r>
              <a:rPr lang="en-GB" sz="1200" dirty="0"/>
              <a:t>). There were no significant main effects of genotype or trauma group following </a:t>
            </a:r>
            <a:r>
              <a:rPr lang="en-GB" sz="1200" i="1" dirty="0"/>
              <a:t>post hoc </a:t>
            </a:r>
            <a:r>
              <a:rPr lang="en-GB" sz="1200" dirty="0"/>
              <a:t>analyses.</a:t>
            </a:r>
            <a:r>
              <a:rPr lang="et-EE" sz="1200" dirty="0"/>
              <a:t> Error bars show +/- 1 standard errors. </a:t>
            </a:r>
            <a:endParaRPr lang="en-GB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4705" y="848180"/>
            <a:ext cx="8545068" cy="341376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358581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27</TotalTime>
  <Words>231</Words>
  <Application>Microsoft Office PowerPoint</Application>
  <PresentationFormat>On-screen Show (4:3)</PresentationFormat>
  <Paragraphs>4</Paragraphs>
  <Slides>3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Symbol</vt:lpstr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ristel Klaus</dc:creator>
  <cp:lastModifiedBy>Kristel Klaus</cp:lastModifiedBy>
  <cp:revision>22</cp:revision>
  <dcterms:created xsi:type="dcterms:W3CDTF">2016-05-11T20:02:50Z</dcterms:created>
  <dcterms:modified xsi:type="dcterms:W3CDTF">2017-03-01T20:08:06Z</dcterms:modified>
</cp:coreProperties>
</file>